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media/image4.wmf" ContentType="image/x-wmf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2314F-09DA-49F6-9F90-E553CDCC68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1CEF0-38F4-4F47-A31F-DA76551687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ABE539-85F1-447C-BAB4-C9E515B2F4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65B6C-5A6C-4084-8F56-07A3A5D44F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EC16B-89F8-4947-9581-A949CB89D3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BE135-9ADE-4D78-B6AA-2AE195C1BC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760A6-6C0E-4635-A188-B0C536640F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FC19A-5D73-4448-B67B-3E254A8886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3B097-383A-4756-A137-3577B2F9A2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E01A7-C3FE-449C-AA6C-43C5F8088F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AB1F6-3CAA-42BF-AE55-67EEC9DC91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B6FEA-1AAD-42DB-8E84-3DC8724F32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5CB6E9-CA7C-4C7E-8A4D-B0E58384E51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package" Target="../embeddings/oleObject1.xlsx"/><Relationship Id="rId4" Type="http://schemas.openxmlformats.org/officeDocument/2006/relationships/image" Target="../media/image2.wmf"/><Relationship Id="rId5" Type="http://schemas.openxmlformats.org/officeDocument/2006/relationships/image" Target="../media/image3.png"/><Relationship Id="rId6" Type="http://schemas.openxmlformats.org/officeDocument/2006/relationships/package" Target="../embeddings/oleObject2.xlsx"/><Relationship Id="rId7" Type="http://schemas.openxmlformats.org/officeDocument/2006/relationships/image" Target="../media/image4.wmf"/><Relationship Id="rId8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22253" t="0" r="65784" b="0"/>
          <a:stretch/>
        </p:blipFill>
        <p:spPr>
          <a:xfrm>
            <a:off x="633240" y="1655640"/>
            <a:ext cx="427320" cy="3969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 rot="19227600">
            <a:off x="601920" y="137448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gf7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12560" y="1014480"/>
            <a:ext cx="120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cn5TAP;sgf73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2"/>
          <a:srcRect l="88999" t="0" r="0" b="0"/>
          <a:stretch/>
        </p:blipFill>
        <p:spPr>
          <a:xfrm>
            <a:off x="1111320" y="1701720"/>
            <a:ext cx="393480" cy="391500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0" y="773280"/>
            <a:ext cx="44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320" y="6491160"/>
            <a:ext cx="347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e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Supplemental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7" name=""/>
          <p:cNvGraphicFramePr/>
          <p:nvPr/>
        </p:nvGraphicFramePr>
        <p:xfrm>
          <a:off x="1986120" y="1292400"/>
          <a:ext cx="2232000" cy="41194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986120" y="1292400"/>
                    <a:ext cx="2232000" cy="4119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1753920" y="772920"/>
            <a:ext cx="439560" cy="49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58800" y="5654520"/>
            <a:ext cx="126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               2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61000" y="14619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732080" y="360684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Ub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776720" y="2509920"/>
            <a:ext cx="77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2Bub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8616200">
            <a:off x="5187960" y="1134360"/>
            <a:ext cx="90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eg.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8598800">
            <a:off x="5775480" y="1260720"/>
            <a:ext cx="75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cn5T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8598800">
            <a:off x="6302160" y="893520"/>
            <a:ext cx="166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cn5TAP;sgf73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Emp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8598800">
            <a:off x="7179840" y="839520"/>
            <a:ext cx="1274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cn5TAP;sgf73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BL525SGF7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5"/>
          <a:srcRect l="0" t="10538" r="51693" b="2890"/>
          <a:stretch/>
        </p:blipFill>
        <p:spPr>
          <a:xfrm>
            <a:off x="5057640" y="1674720"/>
            <a:ext cx="2676600" cy="229572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5230080" y="3925800"/>
            <a:ext cx="23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                     2                  3              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389480" y="410364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529160" y="77328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9010400">
            <a:off x="5177880" y="6280200"/>
            <a:ext cx="42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Neg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8828600">
            <a:off x="5972400" y="6390720"/>
            <a:ext cx="72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Gcn5T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7439760" y="6583320"/>
            <a:ext cx="131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Gcn5TAP;sgf73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7335720" y="6585120"/>
            <a:ext cx="1509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8882000">
            <a:off x="7200720" y="62776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Emp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8882000">
            <a:off x="8283960" y="627948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Sgf7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8" name=""/>
          <p:cNvGraphicFramePr/>
          <p:nvPr/>
        </p:nvGraphicFramePr>
        <p:xfrm>
          <a:off x="4894200" y="4543560"/>
          <a:ext cx="4122720" cy="1758960"/>
        </p:xfrm>
        <a:graphic>
          <a:graphicData uri="http://schemas.openxmlformats.org/presentationml/2006/ole">
            <p:oleObj progId="Excel.Sheet.12" r:id="rId6" spid="">
              <p:embed/>
              <p:pic>
                <p:nvPicPr>
                  <p:cNvPr id="69" name="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4894200" y="4543560"/>
                    <a:ext cx="4122720" cy="1758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0" name=""/>
          <p:cNvSpPr/>
          <p:nvPr/>
        </p:nvSpPr>
        <p:spPr>
          <a:xfrm rot="16200000">
            <a:off x="4090680" y="5328360"/>
            <a:ext cx="132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% Deubiquitin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592520" y="4513320"/>
            <a:ext cx="4418280" cy="231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13T21:53:37Z</dcterms:created>
  <dc:creator>kel</dc:creator>
  <dc:description/>
  <dc:language>en-US</dc:language>
  <cp:lastModifiedBy>kel</cp:lastModifiedBy>
  <dcterms:modified xsi:type="dcterms:W3CDTF">2008-11-20T16:47:42Z</dcterms:modified>
  <cp:revision>2</cp:revision>
  <dc:subject/>
  <dc:title>B. </dc:title>
</cp:coreProperties>
</file>